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 showGuides="1">
      <p:cViewPr varScale="1">
        <p:scale>
          <a:sx n="76" d="100"/>
          <a:sy n="76" d="100"/>
        </p:scale>
        <p:origin x="126" y="79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1!$B$1</c:f>
              <c:strCache>
                <c:ptCount val="1"/>
                <c:pt idx="0">
                  <c:v>Colonne1</c:v>
                </c:pt>
              </c:strCache>
            </c:strRef>
          </c:tx>
          <c:spPr>
            <a:solidFill>
              <a:schemeClr val="accent1"/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433A-4C51-A8EC-5CE35685A47A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433A-4C51-A8EC-5CE35685A47A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>
                  <a:lumMod val="40000"/>
                  <a:lumOff val="6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433A-4C51-A8EC-5CE35685A47A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6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6-433A-4C51-A8EC-5CE35685A47A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5">
                  <a:lumMod val="40000"/>
                  <a:lumOff val="6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433A-4C51-A8EC-5CE35685A47A}"/>
              </c:ext>
            </c:extLst>
          </c:dPt>
          <c:dLbls>
            <c:numFmt formatCode="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fr-FR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Feuil1!$A$2:$A$7</c:f>
              <c:strCache>
                <c:ptCount val="6"/>
                <c:pt idx="0">
                  <c:v>Microscopic detection of fungal elements in BAL, indicating a mold</c:v>
                </c:pt>
                <c:pt idx="1">
                  <c:v>Positive bronchoalveolar lavage culture</c:v>
                </c:pt>
                <c:pt idx="2">
                  <c:v>Serum galactomannan index &gt; 0.5</c:v>
                </c:pt>
                <c:pt idx="3">
                  <c:v>BAL galactomannan index ≥ 1.0</c:v>
                </c:pt>
                <c:pt idx="4">
                  <c:v>Positive aspergillus PCR in BAL</c:v>
                </c:pt>
                <c:pt idx="5">
                  <c:v>Positive PCR in plasma, serum or whole blood </c:v>
                </c:pt>
              </c:strCache>
            </c:strRef>
          </c:cat>
          <c:val>
            <c:numRef>
              <c:f>Feuil1!$B$2:$B$7</c:f>
              <c:numCache>
                <c:formatCode>General</c:formatCode>
                <c:ptCount val="6"/>
                <c:pt idx="0">
                  <c:v>0.16666666699999999</c:v>
                </c:pt>
                <c:pt idx="1">
                  <c:v>0.58333333300000001</c:v>
                </c:pt>
                <c:pt idx="2">
                  <c:v>0.16666666699999999</c:v>
                </c:pt>
                <c:pt idx="3">
                  <c:v>0.33333333300000001</c:v>
                </c:pt>
                <c:pt idx="4">
                  <c:v>0.58333333300000001</c:v>
                </c:pt>
                <c:pt idx="5">
                  <c:v>4.1666666999999998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33A-4C51-A8EC-5CE35685A47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3040992"/>
        <c:axId val="423045584"/>
      </c:barChart>
      <c:catAx>
        <c:axId val="4230409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423045584"/>
        <c:crosses val="autoZero"/>
        <c:auto val="1"/>
        <c:lblAlgn val="ctr"/>
        <c:lblOffset val="100"/>
        <c:noMultiLvlLbl val="0"/>
      </c:catAx>
      <c:valAx>
        <c:axId val="423045584"/>
        <c:scaling>
          <c:orientation val="minMax"/>
          <c:max val="1"/>
        </c:scaling>
        <c:delete val="0"/>
        <c:axPos val="l"/>
        <c:numFmt formatCode="0%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4230409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fr-F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1!$B$1</c:f>
              <c:strCache>
                <c:ptCount val="1"/>
                <c:pt idx="0">
                  <c:v>Colonne1</c:v>
                </c:pt>
              </c:strCache>
            </c:strRef>
          </c:tx>
          <c:spPr>
            <a:solidFill>
              <a:schemeClr val="accent1"/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433A-4C51-A8EC-5CE35685A47A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433A-4C51-A8EC-5CE35685A47A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>
                  <a:lumMod val="40000"/>
                  <a:lumOff val="6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433A-4C51-A8EC-5CE35685A47A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6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6-433A-4C51-A8EC-5CE35685A47A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5">
                  <a:lumMod val="40000"/>
                  <a:lumOff val="6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433A-4C51-A8EC-5CE35685A47A}"/>
              </c:ext>
            </c:extLst>
          </c:dPt>
          <c:dLbls>
            <c:numFmt formatCode="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fr-FR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Feuil1!$A$2:$A$6</c:f>
              <c:strCache>
                <c:ptCount val="5"/>
                <c:pt idx="0">
                  <c:v>Microscopic detection of fungal elements in non-BAL, indicating a mold</c:v>
                </c:pt>
                <c:pt idx="1">
                  <c:v>Positive non-BAL culture</c:v>
                </c:pt>
                <c:pt idx="2">
                  <c:v>Single non-BAL galactomannan index &gt; 4.5</c:v>
                </c:pt>
                <c:pt idx="3">
                  <c:v>≥2 non-BAL galactomannan index &gt; 1.2 </c:v>
                </c:pt>
                <c:pt idx="4">
                  <c:v>Non-BAL galactomannan index &gt; 1.2 plus non-BAL PCR positive test</c:v>
                </c:pt>
              </c:strCache>
            </c:strRef>
          </c:cat>
          <c:val>
            <c:numRef>
              <c:f>Feuil1!$B$2:$B$6</c:f>
              <c:numCache>
                <c:formatCode>General</c:formatCode>
                <c:ptCount val="5"/>
                <c:pt idx="0">
                  <c:v>0.2</c:v>
                </c:pt>
                <c:pt idx="1">
                  <c:v>0.6</c:v>
                </c:pt>
                <c:pt idx="2">
                  <c:v>0</c:v>
                </c:pt>
                <c:pt idx="3">
                  <c:v>0</c:v>
                </c:pt>
                <c:pt idx="4">
                  <c:v>0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33A-4C51-A8EC-5CE35685A47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3040992"/>
        <c:axId val="423045584"/>
      </c:barChart>
      <c:catAx>
        <c:axId val="4230409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423045584"/>
        <c:crosses val="autoZero"/>
        <c:auto val="1"/>
        <c:lblAlgn val="ctr"/>
        <c:lblOffset val="100"/>
        <c:noMultiLvlLbl val="0"/>
      </c:catAx>
      <c:valAx>
        <c:axId val="423045584"/>
        <c:scaling>
          <c:orientation val="minMax"/>
          <c:max val="1"/>
        </c:scaling>
        <c:delete val="0"/>
        <c:axPos val="l"/>
        <c:numFmt formatCode="0%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4230409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FA36F-0014-42B2-A84F-DF261AD02593}" type="datetimeFigureOut">
              <a:rPr lang="fr-FR" smtClean="0"/>
              <a:t>09/08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A50A9-E038-421D-BAF9-EAD3D4A4D44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36835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FA36F-0014-42B2-A84F-DF261AD02593}" type="datetimeFigureOut">
              <a:rPr lang="fr-FR" smtClean="0"/>
              <a:t>09/08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A50A9-E038-421D-BAF9-EAD3D4A4D44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992292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FA36F-0014-42B2-A84F-DF261AD02593}" type="datetimeFigureOut">
              <a:rPr lang="fr-FR" smtClean="0"/>
              <a:t>09/08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A50A9-E038-421D-BAF9-EAD3D4A4D44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125099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FA36F-0014-42B2-A84F-DF261AD02593}" type="datetimeFigureOut">
              <a:rPr lang="fr-FR" smtClean="0"/>
              <a:t>09/08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A50A9-E038-421D-BAF9-EAD3D4A4D44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293225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FA36F-0014-42B2-A84F-DF261AD02593}" type="datetimeFigureOut">
              <a:rPr lang="fr-FR" smtClean="0"/>
              <a:t>09/08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A50A9-E038-421D-BAF9-EAD3D4A4D44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343151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FA36F-0014-42B2-A84F-DF261AD02593}" type="datetimeFigureOut">
              <a:rPr lang="fr-FR" smtClean="0"/>
              <a:t>09/08/202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A50A9-E038-421D-BAF9-EAD3D4A4D44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143375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FA36F-0014-42B2-A84F-DF261AD02593}" type="datetimeFigureOut">
              <a:rPr lang="fr-FR" smtClean="0"/>
              <a:t>09/08/2023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A50A9-E038-421D-BAF9-EAD3D4A4D44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6417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FA36F-0014-42B2-A84F-DF261AD02593}" type="datetimeFigureOut">
              <a:rPr lang="fr-FR" smtClean="0"/>
              <a:t>09/08/2023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A50A9-E038-421D-BAF9-EAD3D4A4D44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82780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FA36F-0014-42B2-A84F-DF261AD02593}" type="datetimeFigureOut">
              <a:rPr lang="fr-FR" smtClean="0"/>
              <a:t>09/08/2023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A50A9-E038-421D-BAF9-EAD3D4A4D44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258643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FA36F-0014-42B2-A84F-DF261AD02593}" type="datetimeFigureOut">
              <a:rPr lang="fr-FR" smtClean="0"/>
              <a:t>09/08/202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A50A9-E038-421D-BAF9-EAD3D4A4D44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503601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FA36F-0014-42B2-A84F-DF261AD02593}" type="datetimeFigureOut">
              <a:rPr lang="fr-FR" smtClean="0"/>
              <a:t>09/08/202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A50A9-E038-421D-BAF9-EAD3D4A4D44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836253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4FA36F-0014-42B2-A84F-DF261AD02593}" type="datetimeFigureOut">
              <a:rPr lang="fr-FR" smtClean="0"/>
              <a:t>09/08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EA50A9-E038-421D-BAF9-EAD3D4A4D44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764767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phique 3"/>
          <p:cNvGraphicFramePr/>
          <p:nvPr/>
        </p:nvGraphicFramePr>
        <p:xfrm>
          <a:off x="1314450" y="190500"/>
          <a:ext cx="9563100" cy="6477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ZoneTexte 1"/>
          <p:cNvSpPr txBox="1"/>
          <p:nvPr/>
        </p:nvSpPr>
        <p:spPr>
          <a:xfrm>
            <a:off x="4456577" y="190500"/>
            <a:ext cx="330930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u="sng" dirty="0" err="1" smtClean="0"/>
              <a:t>Proven</a:t>
            </a:r>
            <a:r>
              <a:rPr lang="fr-FR" sz="2000" b="1" u="sng" dirty="0" smtClean="0"/>
              <a:t>/probable CAPA, </a:t>
            </a:r>
            <a:r>
              <a:rPr lang="fr-FR" sz="2000" b="1" i="1" u="sng" dirty="0" smtClean="0"/>
              <a:t>N</a:t>
            </a:r>
            <a:r>
              <a:rPr lang="fr-FR" sz="2000" b="1" u="sng" dirty="0" smtClean="0"/>
              <a:t>=24</a:t>
            </a:r>
            <a:endParaRPr lang="fr-FR" sz="2000" b="1" u="sng" dirty="0"/>
          </a:p>
        </p:txBody>
      </p:sp>
    </p:spTree>
    <p:extLst>
      <p:ext uri="{BB962C8B-B14F-4D97-AF65-F5344CB8AC3E}">
        <p14:creationId xmlns:p14="http://schemas.microsoft.com/office/powerpoint/2010/main" val="9119588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phique 3"/>
          <p:cNvGraphicFramePr/>
          <p:nvPr>
            <p:extLst>
              <p:ext uri="{D42A27DB-BD31-4B8C-83A1-F6EECF244321}">
                <p14:modId xmlns:p14="http://schemas.microsoft.com/office/powerpoint/2010/main" val="1362366414"/>
              </p:ext>
            </p:extLst>
          </p:nvPr>
        </p:nvGraphicFramePr>
        <p:xfrm>
          <a:off x="1314450" y="190500"/>
          <a:ext cx="9563100" cy="6477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ZoneTexte 2"/>
          <p:cNvSpPr txBox="1"/>
          <p:nvPr/>
        </p:nvSpPr>
        <p:spPr>
          <a:xfrm>
            <a:off x="4456577" y="190500"/>
            <a:ext cx="222939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u="sng" dirty="0" smtClean="0"/>
              <a:t>Possible CAPA, </a:t>
            </a:r>
            <a:r>
              <a:rPr lang="fr-FR" sz="2000" b="1" i="1" u="sng" dirty="0"/>
              <a:t>N</a:t>
            </a:r>
            <a:r>
              <a:rPr lang="fr-FR" sz="2000" b="1" u="sng" dirty="0" smtClean="0"/>
              <a:t>=5</a:t>
            </a:r>
            <a:endParaRPr lang="fr-FR" sz="2000" b="1" u="sng" dirty="0"/>
          </a:p>
        </p:txBody>
      </p:sp>
    </p:spTree>
    <p:extLst>
      <p:ext uri="{BB962C8B-B14F-4D97-AF65-F5344CB8AC3E}">
        <p14:creationId xmlns:p14="http://schemas.microsoft.com/office/powerpoint/2010/main" val="15282948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4</TotalTime>
  <Words>8</Words>
  <Application>Microsoft Office PowerPoint</Application>
  <PresentationFormat>Grand écran</PresentationFormat>
  <Paragraphs>2</Paragraphs>
  <Slides>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Présentation PowerPoint</vt:lpstr>
      <vt:lpstr>Présentation PowerPoint</vt:lpstr>
    </vt:vector>
  </TitlesOfParts>
  <Company>AP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AY Pierre</dc:creator>
  <cp:lastModifiedBy>BAY Pierre</cp:lastModifiedBy>
  <cp:revision>11</cp:revision>
  <dcterms:created xsi:type="dcterms:W3CDTF">2023-07-25T15:18:05Z</dcterms:created>
  <dcterms:modified xsi:type="dcterms:W3CDTF">2023-08-09T07:24:21Z</dcterms:modified>
</cp:coreProperties>
</file>